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9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18730649-E520-4CEA-54CC-F084ABAAFD6C}" name="Sunanda Williams (Staff)" initials="SW" userId="S::sunanda.williams@bbk.ac.uk::70673de6-3bcb-457a-95c0-1500b9ad1436" providerId="AD"/>
  <p188:author id="{BC558BF1-2523-4177-F462-8F6084805721}" name="Sunanda Margrett Williams" initials="SW" userId="S::sunandaw@iisc.ac.in::faa5e29f-cf08-435e-b04c-65f24aa99f9c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1FF"/>
    <a:srgbClr val="00FA00"/>
    <a:srgbClr val="FF40FF"/>
    <a:srgbClr val="E453E8"/>
    <a:srgbClr val="FF85FF"/>
    <a:srgbClr val="D4EEB2"/>
    <a:srgbClr val="8EEAAE"/>
    <a:srgbClr val="EDB8EF"/>
    <a:srgbClr val="EEDCF6"/>
    <a:srgbClr val="A7ECE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4577"/>
    <p:restoredTop sz="96327"/>
  </p:normalViewPr>
  <p:slideViewPr>
    <p:cSldViewPr snapToGrid="0" snapToObjects="1">
      <p:cViewPr>
        <p:scale>
          <a:sx n="226" d="100"/>
          <a:sy n="226" d="100"/>
        </p:scale>
        <p:origin x="-40" y="-33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E04F5-B418-E64B-B7A9-A7305847B83B}" type="datetimeFigureOut">
              <a:rPr lang="en-US" smtClean="0"/>
              <a:t>3/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B3DDB7-9F57-3945-9FE4-B6DFDE021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71892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E04F5-B418-E64B-B7A9-A7305847B83B}" type="datetimeFigureOut">
              <a:rPr lang="en-US" smtClean="0"/>
              <a:t>3/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B3DDB7-9F57-3945-9FE4-B6DFDE021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82494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E04F5-B418-E64B-B7A9-A7305847B83B}" type="datetimeFigureOut">
              <a:rPr lang="en-US" smtClean="0"/>
              <a:t>3/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B3DDB7-9F57-3945-9FE4-B6DFDE021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91492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E04F5-B418-E64B-B7A9-A7305847B83B}" type="datetimeFigureOut">
              <a:rPr lang="en-US" smtClean="0"/>
              <a:t>3/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B3DDB7-9F57-3945-9FE4-B6DFDE021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02512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E04F5-B418-E64B-B7A9-A7305847B83B}" type="datetimeFigureOut">
              <a:rPr lang="en-US" smtClean="0"/>
              <a:t>3/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B3DDB7-9F57-3945-9FE4-B6DFDE021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99208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E04F5-B418-E64B-B7A9-A7305847B83B}" type="datetimeFigureOut">
              <a:rPr lang="en-US" smtClean="0"/>
              <a:t>3/7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B3DDB7-9F57-3945-9FE4-B6DFDE021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00365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E04F5-B418-E64B-B7A9-A7305847B83B}" type="datetimeFigureOut">
              <a:rPr lang="en-US" smtClean="0"/>
              <a:t>3/7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B3DDB7-9F57-3945-9FE4-B6DFDE021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40957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E04F5-B418-E64B-B7A9-A7305847B83B}" type="datetimeFigureOut">
              <a:rPr lang="en-US" smtClean="0"/>
              <a:t>3/7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B3DDB7-9F57-3945-9FE4-B6DFDE021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92559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E04F5-B418-E64B-B7A9-A7305847B83B}" type="datetimeFigureOut">
              <a:rPr lang="en-US" smtClean="0"/>
              <a:t>3/7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B3DDB7-9F57-3945-9FE4-B6DFDE021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81967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E04F5-B418-E64B-B7A9-A7305847B83B}" type="datetimeFigureOut">
              <a:rPr lang="en-US" smtClean="0"/>
              <a:t>3/7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B3DDB7-9F57-3945-9FE4-B6DFDE021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4519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E04F5-B418-E64B-B7A9-A7305847B83B}" type="datetimeFigureOut">
              <a:rPr lang="en-US" smtClean="0"/>
              <a:t>3/7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B3DDB7-9F57-3945-9FE4-B6DFDE021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38524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AE04F5-B418-E64B-B7A9-A7305847B83B}" type="datetimeFigureOut">
              <a:rPr lang="en-US" smtClean="0"/>
              <a:t>3/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B3DDB7-9F57-3945-9FE4-B6DFDE021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09508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16">
            <a:extLst>
              <a:ext uri="{FF2B5EF4-FFF2-40B4-BE49-F238E27FC236}">
                <a16:creationId xmlns:a16="http://schemas.microsoft.com/office/drawing/2014/main" id="{81A34C66-D997-3F02-BC2D-A8E05B9F1FF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2916" y="2447597"/>
            <a:ext cx="2302572" cy="22309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" name="Picture 18" descr="A blue and white glass&#10;&#10;AI-generated content may be incorrect.">
            <a:extLst>
              <a:ext uri="{FF2B5EF4-FFF2-40B4-BE49-F238E27FC236}">
                <a16:creationId xmlns:a16="http://schemas.microsoft.com/office/drawing/2014/main" id="{E737CBC3-9161-A9D0-40FD-43D6ED843A7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31797" y="5027553"/>
            <a:ext cx="2372800" cy="225546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0FB1207-DD8F-EA4E-E3D4-2D762580154F}"/>
              </a:ext>
            </a:extLst>
          </p:cNvPr>
          <p:cNvSpPr txBox="1"/>
          <p:nvPr/>
        </p:nvSpPr>
        <p:spPr>
          <a:xfrm>
            <a:off x="74951" y="438076"/>
            <a:ext cx="6708098" cy="193899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/>
              <a:t>Uncropped gel images.</a:t>
            </a:r>
          </a:p>
          <a:p>
            <a:r>
              <a:rPr lang="en-GB" sz="1200" dirty="0"/>
              <a:t>See legends and contents of corresponding figure panels for lane, band and MW (</a:t>
            </a:r>
            <a:r>
              <a:rPr lang="en-GB" sz="1200" dirty="0" err="1"/>
              <a:t>kDa</a:t>
            </a:r>
            <a:r>
              <a:rPr lang="en-GB" sz="1200" dirty="0"/>
              <a:t>) identifiers. Areas shown in corresponding figures are indicated within a dashed line box</a:t>
            </a:r>
            <a:r>
              <a:rPr lang="en-GB" sz="1200"/>
              <a:t>. </a:t>
            </a:r>
            <a:endParaRPr lang="en-GB" sz="1200" dirty="0"/>
          </a:p>
          <a:p>
            <a:r>
              <a:rPr lang="en-GB" sz="1200" dirty="0"/>
              <a:t>a, Raw data gel image for Fig. 1a.</a:t>
            </a:r>
          </a:p>
          <a:p>
            <a:r>
              <a:rPr lang="en-GB" sz="1200" dirty="0"/>
              <a:t>b, Raw data gel image for Supplementary Fig. 3. </a:t>
            </a:r>
          </a:p>
          <a:p>
            <a:r>
              <a:rPr lang="en-GB" sz="1200" dirty="0"/>
              <a:t>c, Raw data gel image for Supplementary Fig. 6 a. </a:t>
            </a:r>
          </a:p>
          <a:p>
            <a:r>
              <a:rPr lang="en-GB" sz="1200" dirty="0"/>
              <a:t>d, Raw data gel image for Supplementary Fig. 6 b. </a:t>
            </a:r>
          </a:p>
          <a:p>
            <a:r>
              <a:rPr lang="en-GB" sz="1200" dirty="0"/>
              <a:t>e, Raw data gel image for Supplementary Fig. 6 c. </a:t>
            </a:r>
          </a:p>
          <a:p>
            <a:endParaRPr lang="en-GB" sz="1200" dirty="0"/>
          </a:p>
          <a:p>
            <a:r>
              <a:rPr lang="en-GB" sz="1200" dirty="0"/>
              <a:t> </a:t>
            </a:r>
            <a:endParaRPr lang="en-US" sz="12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0A9D747-DD1E-86D9-59EA-22D32FAFA872}"/>
              </a:ext>
            </a:extLst>
          </p:cNvPr>
          <p:cNvSpPr txBox="1"/>
          <p:nvPr/>
        </p:nvSpPr>
        <p:spPr>
          <a:xfrm>
            <a:off x="74951" y="2346829"/>
            <a:ext cx="2712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3DACA43-3FAB-C8A0-0D96-A01534ED6187}"/>
              </a:ext>
            </a:extLst>
          </p:cNvPr>
          <p:cNvSpPr txBox="1"/>
          <p:nvPr/>
        </p:nvSpPr>
        <p:spPr>
          <a:xfrm>
            <a:off x="74951" y="5039760"/>
            <a:ext cx="2600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0BADFFC-D832-AEE2-32C0-86C872500C7F}"/>
              </a:ext>
            </a:extLst>
          </p:cNvPr>
          <p:cNvSpPr txBox="1"/>
          <p:nvPr/>
        </p:nvSpPr>
        <p:spPr>
          <a:xfrm>
            <a:off x="3616163" y="2346829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2C50D6E-725C-0010-7DDD-08552E844C73}"/>
              </a:ext>
            </a:extLst>
          </p:cNvPr>
          <p:cNvSpPr txBox="1"/>
          <p:nvPr/>
        </p:nvSpPr>
        <p:spPr>
          <a:xfrm>
            <a:off x="3616163" y="5039760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d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64EF98C-E9F2-1766-1681-CA7D4A3232A7}"/>
              </a:ext>
            </a:extLst>
          </p:cNvPr>
          <p:cNvSpPr txBox="1"/>
          <p:nvPr/>
        </p:nvSpPr>
        <p:spPr>
          <a:xfrm>
            <a:off x="1827314" y="7331016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e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FBDADD0F-27FF-23BA-4641-9FD244CA78C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05780" y="2476801"/>
            <a:ext cx="2368598" cy="2368598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765DF49D-C6A1-D0CE-9D52-AE3BD793775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4165" y="5079747"/>
            <a:ext cx="2072451" cy="2049381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0B62C7EB-5B67-3DE3-DA01-8C68B5D99C9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186260" y="7465171"/>
            <a:ext cx="2340293" cy="2255464"/>
          </a:xfrm>
          <a:prstGeom prst="rect">
            <a:avLst/>
          </a:prstGeom>
        </p:spPr>
      </p:pic>
      <p:sp>
        <p:nvSpPr>
          <p:cNvPr id="20" name="Rectangle 19">
            <a:extLst>
              <a:ext uri="{FF2B5EF4-FFF2-40B4-BE49-F238E27FC236}">
                <a16:creationId xmlns:a16="http://schemas.microsoft.com/office/drawing/2014/main" id="{68079923-9DFB-54ED-6819-B6389128D951}"/>
              </a:ext>
            </a:extLst>
          </p:cNvPr>
          <p:cNvSpPr/>
          <p:nvPr/>
        </p:nvSpPr>
        <p:spPr>
          <a:xfrm>
            <a:off x="465809" y="2821283"/>
            <a:ext cx="308168" cy="1576204"/>
          </a:xfrm>
          <a:prstGeom prst="rect">
            <a:avLst/>
          </a:prstGeom>
          <a:noFill/>
          <a:ln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1E950206-515C-091F-33B5-AE402095ED31}"/>
              </a:ext>
            </a:extLst>
          </p:cNvPr>
          <p:cNvSpPr/>
          <p:nvPr/>
        </p:nvSpPr>
        <p:spPr>
          <a:xfrm>
            <a:off x="1111547" y="2822884"/>
            <a:ext cx="257692" cy="1576204"/>
          </a:xfrm>
          <a:prstGeom prst="rect">
            <a:avLst/>
          </a:prstGeom>
          <a:noFill/>
          <a:ln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181AEE00-ED36-9D42-9550-10F91E1CA7EA}"/>
              </a:ext>
            </a:extLst>
          </p:cNvPr>
          <p:cNvSpPr/>
          <p:nvPr/>
        </p:nvSpPr>
        <p:spPr>
          <a:xfrm>
            <a:off x="4651612" y="2654606"/>
            <a:ext cx="734776" cy="1653786"/>
          </a:xfrm>
          <a:prstGeom prst="rect">
            <a:avLst/>
          </a:prstGeom>
          <a:noFill/>
          <a:ln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02A51FF1-8F76-24F1-8D6F-F9F69F3A617E}"/>
              </a:ext>
            </a:extLst>
          </p:cNvPr>
          <p:cNvSpPr/>
          <p:nvPr/>
        </p:nvSpPr>
        <p:spPr>
          <a:xfrm>
            <a:off x="1281976" y="5281635"/>
            <a:ext cx="682555" cy="1571926"/>
          </a:xfrm>
          <a:prstGeom prst="rect">
            <a:avLst/>
          </a:prstGeom>
          <a:noFill/>
          <a:ln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FC8B2C11-D6B4-1AB3-CA95-28183BDCA265}"/>
              </a:ext>
            </a:extLst>
          </p:cNvPr>
          <p:cNvSpPr/>
          <p:nvPr/>
        </p:nvSpPr>
        <p:spPr>
          <a:xfrm>
            <a:off x="4673894" y="5245270"/>
            <a:ext cx="776942" cy="1528941"/>
          </a:xfrm>
          <a:prstGeom prst="rect">
            <a:avLst/>
          </a:prstGeom>
          <a:noFill/>
          <a:ln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2D254DCD-4E0B-7063-0E40-BED103BC0902}"/>
              </a:ext>
            </a:extLst>
          </p:cNvPr>
          <p:cNvSpPr/>
          <p:nvPr/>
        </p:nvSpPr>
        <p:spPr>
          <a:xfrm flipV="1">
            <a:off x="2687568" y="7705524"/>
            <a:ext cx="765844" cy="1624905"/>
          </a:xfrm>
          <a:prstGeom prst="rect">
            <a:avLst/>
          </a:prstGeom>
          <a:noFill/>
          <a:ln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57819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resentation3" id="{36081DDE-67C5-4849-8381-E8C1A228D453}" vid="{E2793F4B-1342-6D46-99CA-5F00C42E5305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82</TotalTime>
  <Words>104</Words>
  <Application>Microsoft Macintosh PowerPoint</Application>
  <PresentationFormat>A4 Paper (210x297 mm)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ksman, Gabriel</dc:creator>
  <cp:lastModifiedBy>Sunanda Margrett Williams</cp:lastModifiedBy>
  <cp:revision>209</cp:revision>
  <cp:lastPrinted>2024-01-19T12:53:25Z</cp:lastPrinted>
  <dcterms:created xsi:type="dcterms:W3CDTF">2024-01-19T08:15:49Z</dcterms:created>
  <dcterms:modified xsi:type="dcterms:W3CDTF">2025-03-07T17:49:09Z</dcterms:modified>
</cp:coreProperties>
</file>